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34" userDrawn="1">
          <p15:clr>
            <a:srgbClr val="A4A3A4"/>
          </p15:clr>
        </p15:guide>
        <p15:guide id="2" pos="84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64" d="100"/>
          <a:sy n="64" d="100"/>
        </p:scale>
        <p:origin x="3318" y="90"/>
      </p:cViewPr>
      <p:guideLst>
        <p:guide orient="horz" pos="234"/>
        <p:guide pos="84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09AC0E-788E-4010-92BC-817F24111E2D}" type="datetimeFigureOut">
              <a:rPr lang="en-GB" smtClean="0"/>
              <a:t>05/09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9F00E5-11F6-452A-AC9F-F4EB36EF0E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642035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09AC0E-788E-4010-92BC-817F24111E2D}" type="datetimeFigureOut">
              <a:rPr lang="en-GB" smtClean="0"/>
              <a:t>05/09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9F00E5-11F6-452A-AC9F-F4EB36EF0E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185031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09AC0E-788E-4010-92BC-817F24111E2D}" type="datetimeFigureOut">
              <a:rPr lang="en-GB" smtClean="0"/>
              <a:t>05/09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9F00E5-11F6-452A-AC9F-F4EB36EF0E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586757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09AC0E-788E-4010-92BC-817F24111E2D}" type="datetimeFigureOut">
              <a:rPr lang="en-GB" smtClean="0"/>
              <a:t>05/09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9F00E5-11F6-452A-AC9F-F4EB36EF0E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516310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09AC0E-788E-4010-92BC-817F24111E2D}" type="datetimeFigureOut">
              <a:rPr lang="en-GB" smtClean="0"/>
              <a:t>05/09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9F00E5-11F6-452A-AC9F-F4EB36EF0E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953032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09AC0E-788E-4010-92BC-817F24111E2D}" type="datetimeFigureOut">
              <a:rPr lang="en-GB" smtClean="0"/>
              <a:t>05/09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9F00E5-11F6-452A-AC9F-F4EB36EF0E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988015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09AC0E-788E-4010-92BC-817F24111E2D}" type="datetimeFigureOut">
              <a:rPr lang="en-GB" smtClean="0"/>
              <a:t>05/09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9F00E5-11F6-452A-AC9F-F4EB36EF0E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166777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09AC0E-788E-4010-92BC-817F24111E2D}" type="datetimeFigureOut">
              <a:rPr lang="en-GB" smtClean="0"/>
              <a:t>05/09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9F00E5-11F6-452A-AC9F-F4EB36EF0E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789943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09AC0E-788E-4010-92BC-817F24111E2D}" type="datetimeFigureOut">
              <a:rPr lang="en-GB" smtClean="0"/>
              <a:t>05/09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9F00E5-11F6-452A-AC9F-F4EB36EF0E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470535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09AC0E-788E-4010-92BC-817F24111E2D}" type="datetimeFigureOut">
              <a:rPr lang="en-GB" smtClean="0"/>
              <a:t>05/09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9F00E5-11F6-452A-AC9F-F4EB36EF0E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779838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09AC0E-788E-4010-92BC-817F24111E2D}" type="datetimeFigureOut">
              <a:rPr lang="en-GB" smtClean="0"/>
              <a:t>05/09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9F00E5-11F6-452A-AC9F-F4EB36EF0E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151944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09AC0E-788E-4010-92BC-817F24111E2D}" type="datetimeFigureOut">
              <a:rPr lang="en-GB" smtClean="0"/>
              <a:t>05/09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9F00E5-11F6-452A-AC9F-F4EB36EF0E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883029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" name="Picture 2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7483" y="382275"/>
            <a:ext cx="2148094" cy="1564237"/>
          </a:xfrm>
          <a:prstGeom prst="rect">
            <a:avLst/>
          </a:prstGeom>
        </p:spPr>
      </p:pic>
      <p:pic>
        <p:nvPicPr>
          <p:cNvPr id="27" name="Picture 2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01327" y="371475"/>
            <a:ext cx="2148094" cy="1564237"/>
          </a:xfrm>
          <a:prstGeom prst="rect">
            <a:avLst/>
          </a:prstGeom>
        </p:spPr>
      </p:pic>
      <p:pic>
        <p:nvPicPr>
          <p:cNvPr id="28" name="Picture 27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81563" y="400195"/>
            <a:ext cx="2117529" cy="1541979"/>
          </a:xfrm>
          <a:prstGeom prst="rect">
            <a:avLst/>
          </a:prstGeom>
        </p:spPr>
      </p:pic>
      <p:pic>
        <p:nvPicPr>
          <p:cNvPr id="29" name="Picture 28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9779" y="1938262"/>
            <a:ext cx="2123502" cy="1546329"/>
          </a:xfrm>
          <a:prstGeom prst="rect">
            <a:avLst/>
          </a:prstGeom>
        </p:spPr>
      </p:pic>
      <p:pic>
        <p:nvPicPr>
          <p:cNvPr id="30" name="Picture 29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13623" y="1931587"/>
            <a:ext cx="2123502" cy="1546329"/>
          </a:xfrm>
          <a:prstGeom prst="rect">
            <a:avLst/>
          </a:prstGeom>
        </p:spPr>
      </p:pic>
      <p:pic>
        <p:nvPicPr>
          <p:cNvPr id="31" name="Picture 30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81563" y="1931586"/>
            <a:ext cx="2123502" cy="1546329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F8C90474-D816-4422-886F-980512AC7438}"/>
              </a:ext>
            </a:extLst>
          </p:cNvPr>
          <p:cNvSpPr txBox="1"/>
          <p:nvPr/>
        </p:nvSpPr>
        <p:spPr>
          <a:xfrm>
            <a:off x="542925" y="3806126"/>
            <a:ext cx="577215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/>
              <a:t>Supplementary Figure 3. Distribution of individual total (combined adenomatous and serrated polyp) colorectal polyp counts according to seAFOod trial treatment allocation by factorial margins and TP53 rs104522 genotype. </a:t>
            </a:r>
            <a:r>
              <a:rPr lang="en-US" sz="1200" dirty="0"/>
              <a:t>The difference between total colorectal polyp number between treatment groups for each genotype was compared using the Kruskal-Wallis rank test.</a:t>
            </a:r>
            <a:endParaRPr lang="en-GB" sz="1200" b="1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F1CE5FC9-298D-48CE-A99D-17B4FEACD9C0}"/>
              </a:ext>
            </a:extLst>
          </p:cNvPr>
          <p:cNvSpPr txBox="1"/>
          <p:nvPr/>
        </p:nvSpPr>
        <p:spPr>
          <a:xfrm>
            <a:off x="1227783" y="561975"/>
            <a:ext cx="6439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=0.24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2462C3B-975F-43EA-A929-DD65B5A5BEAE}"/>
              </a:ext>
            </a:extLst>
          </p:cNvPr>
          <p:cNvSpPr txBox="1"/>
          <p:nvPr/>
        </p:nvSpPr>
        <p:spPr>
          <a:xfrm>
            <a:off x="3346723" y="561975"/>
            <a:ext cx="6439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=0.67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70B37895-6DD6-4ABE-B471-4EC3D4B83F39}"/>
              </a:ext>
            </a:extLst>
          </p:cNvPr>
          <p:cNvSpPr txBox="1"/>
          <p:nvPr/>
        </p:nvSpPr>
        <p:spPr>
          <a:xfrm>
            <a:off x="5217655" y="554740"/>
            <a:ext cx="6439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=0.03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17CB99B-07D5-43B6-B90C-BDABD9D94D5A}"/>
              </a:ext>
            </a:extLst>
          </p:cNvPr>
          <p:cNvSpPr txBox="1"/>
          <p:nvPr/>
        </p:nvSpPr>
        <p:spPr>
          <a:xfrm>
            <a:off x="1231115" y="2117962"/>
            <a:ext cx="6439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=0.52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E8FB6CB7-E3B7-4F92-B333-38FBDBA9FEC0}"/>
              </a:ext>
            </a:extLst>
          </p:cNvPr>
          <p:cNvSpPr txBox="1"/>
          <p:nvPr/>
        </p:nvSpPr>
        <p:spPr>
          <a:xfrm>
            <a:off x="3357172" y="2134136"/>
            <a:ext cx="6439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=0.67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07ADBD17-D8E5-431D-89D3-D4A9C591EABD}"/>
              </a:ext>
            </a:extLst>
          </p:cNvPr>
          <p:cNvSpPr txBox="1"/>
          <p:nvPr/>
        </p:nvSpPr>
        <p:spPr>
          <a:xfrm>
            <a:off x="5224979" y="2123718"/>
            <a:ext cx="6439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=0.38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938622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2</TotalTime>
  <Words>59</Words>
  <Application>Microsoft Office PowerPoint</Application>
  <PresentationFormat>Widescreen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of Leed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k Hull</dc:creator>
  <cp:lastModifiedBy>Mark Hull</cp:lastModifiedBy>
  <cp:revision>13</cp:revision>
  <dcterms:created xsi:type="dcterms:W3CDTF">2022-12-05T11:01:53Z</dcterms:created>
  <dcterms:modified xsi:type="dcterms:W3CDTF">2023-09-05T06:47:06Z</dcterms:modified>
</cp:coreProperties>
</file>